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C34EB-7533-4CB7-986D-40A3AD1186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3FD1B-20B9-46CF-9615-925D327159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986BA-EC56-4F86-8EFC-23FD0474BA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E1C7A-F774-4C14-9189-4A78425C07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94353-6510-4C94-B305-6665910740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0225B-D6A0-4E9F-B544-F1C20D869B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E55FF-6EB4-4522-AEF4-567316596C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13532-4095-4C80-A1C2-0F09235DD7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260ED-EF45-41C8-A288-878F17FA50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CAE67-54A7-456E-908C-35D4FBAAC0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5D96D-5773-427B-9492-A0D47F50CA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A3875-C0E9-4357-A368-C5528EE5EB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4F24D8-0396-4D71-AD0E-3A8BB61509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5.png"/><Relationship Id="rId9" Type="http://schemas.openxmlformats.org/officeDocument/2006/relationships/oleObject" Target="../embeddings/oleObject4.bin"/><Relationship Id="rId10" Type="http://schemas.openxmlformats.org/officeDocument/2006/relationships/image" Target="../media/image6.png"/><Relationship Id="rId11" Type="http://schemas.openxmlformats.org/officeDocument/2006/relationships/oleObject" Target="../embeddings/oleObject5.bin"/><Relationship Id="rId12" Type="http://schemas.openxmlformats.org/officeDocument/2006/relationships/image" Target="../media/image7.png"/><Relationship Id="rId13" Type="http://schemas.openxmlformats.org/officeDocument/2006/relationships/oleObject" Target="../embeddings/oleObject6.bin"/><Relationship Id="rId14" Type="http://schemas.openxmlformats.org/officeDocument/2006/relationships/image" Target="../media/image8.png"/><Relationship Id="rId15" Type="http://schemas.openxmlformats.org/officeDocument/2006/relationships/oleObject" Target="../embeddings/oleObject7.bin"/><Relationship Id="rId16" Type="http://schemas.openxmlformats.org/officeDocument/2006/relationships/image" Target="../media/image9.png"/><Relationship Id="rId17" Type="http://schemas.openxmlformats.org/officeDocument/2006/relationships/oleObject" Target="../embeddings/oleObject8.bin"/><Relationship Id="rId18" Type="http://schemas.openxmlformats.org/officeDocument/2006/relationships/image" Target="../media/image10.png"/><Relationship Id="rId19" Type="http://schemas.openxmlformats.org/officeDocument/2006/relationships/oleObject" Target="../embeddings/oleObject9.bin"/><Relationship Id="rId20" Type="http://schemas.openxmlformats.org/officeDocument/2006/relationships/image" Target="../media/image11.png"/><Relationship Id="rId21" Type="http://schemas.openxmlformats.org/officeDocument/2006/relationships/image" Target="../media/image12.pn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40160" y="1139760"/>
            <a:ext cx="5568480" cy="7177320"/>
            <a:chOff x="740160" y="1139760"/>
            <a:chExt cx="5568480" cy="7177320"/>
          </a:xfrm>
        </p:grpSpPr>
        <p:grpSp>
          <p:nvGrpSpPr>
            <p:cNvPr id="42" name=""/>
            <p:cNvGrpSpPr/>
            <p:nvPr/>
          </p:nvGrpSpPr>
          <p:grpSpPr>
            <a:xfrm>
              <a:off x="773280" y="1187280"/>
              <a:ext cx="5535360" cy="3319560"/>
              <a:chOff x="773280" y="1187280"/>
              <a:chExt cx="5535360" cy="331956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5360" y="1484280"/>
                <a:ext cx="1656000" cy="1509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1125360" y="3060720"/>
                <a:ext cx="1656000" cy="1446120"/>
              </a:xfrm>
              <a:prstGeom prst="rect">
                <a:avLst/>
              </a:prstGeom>
              <a:ln w="0">
                <a:noFill/>
              </a:ln>
            </p:spPr>
          </p:pic>
          <p:graphicFrame>
            <p:nvGraphicFramePr>
              <p:cNvPr id="45" name=""/>
              <p:cNvGraphicFramePr/>
              <p:nvPr/>
            </p:nvGraphicFramePr>
            <p:xfrm>
              <a:off x="2852640" y="1481040"/>
              <a:ext cx="1656000" cy="151308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46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2852640" y="1481040"/>
                        <a:ext cx="1656000" cy="15130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47" name=""/>
              <p:cNvGraphicFramePr/>
              <p:nvPr/>
            </p:nvGraphicFramePr>
            <p:xfrm>
              <a:off x="2852640" y="3065400"/>
              <a:ext cx="1656000" cy="144144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48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2852640" y="3065400"/>
                        <a:ext cx="1656000" cy="14414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49" name=""/>
              <p:cNvGraphicFramePr/>
              <p:nvPr/>
            </p:nvGraphicFramePr>
            <p:xfrm>
              <a:off x="4581360" y="3051000"/>
              <a:ext cx="1727280" cy="144972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50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4581360" y="3051000"/>
                        <a:ext cx="1727280" cy="1449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1" name=""/>
              <p:cNvGraphicFramePr/>
              <p:nvPr/>
            </p:nvGraphicFramePr>
            <p:xfrm>
              <a:off x="4581360" y="1476360"/>
              <a:ext cx="1727280" cy="1527120"/>
            </p:xfrm>
            <a:graphic>
              <a:graphicData uri="http://schemas.openxmlformats.org/presentationml/2006/ole">
                <p:oleObj r:id="rId9" spid="">
                  <p:embed/>
                  <p:pic>
                    <p:nvPicPr>
                      <p:cNvPr id="52" name="" descr=""/>
                      <p:cNvPicPr/>
                      <p:nvPr/>
                    </p:nvPicPr>
                    <p:blipFill>
                      <a:blip r:embed="rId10"/>
                      <a:stretch/>
                    </p:blipFill>
                    <p:spPr>
                      <a:xfrm>
                        <a:off x="4581360" y="1476360"/>
                        <a:ext cx="1727280" cy="1527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3" name=""/>
              <p:cNvSpPr/>
              <p:nvPr/>
            </p:nvSpPr>
            <p:spPr>
              <a:xfrm>
                <a:off x="1341360" y="1187280"/>
                <a:ext cx="4680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 (0 Gy)                     5 Gy, 2 h                          5 Gy, 16 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rot="16200000">
                <a:off x="439200" y="1950840"/>
                <a:ext cx="94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onolaye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rot="16200000">
                <a:off x="167760" y="3475800"/>
                <a:ext cx="149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ammosphe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"/>
            <p:cNvGrpSpPr/>
            <p:nvPr/>
          </p:nvGrpSpPr>
          <p:grpSpPr>
            <a:xfrm>
              <a:off x="822240" y="4851360"/>
              <a:ext cx="5486400" cy="3465720"/>
              <a:chOff x="822240" y="4851360"/>
              <a:chExt cx="5486400" cy="3465720"/>
            </a:xfrm>
          </p:grpSpPr>
          <p:sp>
            <p:nvSpPr>
              <p:cNvPr id="57" name=""/>
              <p:cNvSpPr/>
              <p:nvPr/>
            </p:nvSpPr>
            <p:spPr>
              <a:xfrm>
                <a:off x="1390320" y="4851360"/>
                <a:ext cx="4680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 (0 Gy)                     5 Gy, 2 h                          5 Gy, 16 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58" name=""/>
              <p:cNvGraphicFramePr/>
              <p:nvPr/>
            </p:nvGraphicFramePr>
            <p:xfrm>
              <a:off x="1149120" y="6743880"/>
              <a:ext cx="1643040" cy="156348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59" name="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1149120" y="6743880"/>
                        <a:ext cx="1643040" cy="1563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0" name=""/>
              <p:cNvGraphicFramePr/>
              <p:nvPr/>
            </p:nvGraphicFramePr>
            <p:xfrm>
              <a:off x="2876400" y="6745320"/>
              <a:ext cx="1684080" cy="1571760"/>
            </p:xfrm>
            <a:graphic>
              <a:graphicData uri="http://schemas.openxmlformats.org/presentationml/2006/ole">
                <p:oleObj r:id="rId13" spid="">
                  <p:embed/>
                  <p:pic>
                    <p:nvPicPr>
                      <p:cNvPr id="61" name="" descr=""/>
                      <p:cNvPicPr/>
                      <p:nvPr/>
                    </p:nvPicPr>
                    <p:blipFill>
                      <a:blip r:embed="rId14"/>
                      <a:stretch/>
                    </p:blipFill>
                    <p:spPr>
                      <a:xfrm>
                        <a:off x="2876400" y="6745320"/>
                        <a:ext cx="1684080" cy="157176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2" name=""/>
              <p:cNvGraphicFramePr/>
              <p:nvPr/>
            </p:nvGraphicFramePr>
            <p:xfrm>
              <a:off x="2885760" y="5166000"/>
              <a:ext cx="1677960" cy="152388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63" name="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2885760" y="5166000"/>
                        <a:ext cx="1677960" cy="1523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4" name=""/>
              <p:cNvGraphicFramePr/>
              <p:nvPr/>
            </p:nvGraphicFramePr>
            <p:xfrm>
              <a:off x="1133280" y="5166000"/>
              <a:ext cx="1676520" cy="1523880"/>
            </p:xfrm>
            <a:graphic>
              <a:graphicData uri="http://schemas.openxmlformats.org/presentationml/2006/ole">
                <p:oleObj r:id="rId17" spid="">
                  <p:embed/>
                  <p:pic>
                    <p:nvPicPr>
                      <p:cNvPr id="65" name="" descr=""/>
                      <p:cNvPicPr/>
                      <p:nvPr/>
                    </p:nvPicPr>
                    <p:blipFill>
                      <a:blip r:embed="rId18"/>
                      <a:stretch/>
                    </p:blipFill>
                    <p:spPr>
                      <a:xfrm>
                        <a:off x="1133280" y="5166000"/>
                        <a:ext cx="1676520" cy="1523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6" name=""/>
              <p:cNvGraphicFramePr/>
              <p:nvPr/>
            </p:nvGraphicFramePr>
            <p:xfrm>
              <a:off x="4632120" y="5156280"/>
              <a:ext cx="1676520" cy="1523880"/>
            </p:xfrm>
            <a:graphic>
              <a:graphicData uri="http://schemas.openxmlformats.org/presentationml/2006/ole">
                <p:oleObj r:id="rId19" spid="">
                  <p:embed/>
                  <p:pic>
                    <p:nvPicPr>
                      <p:cNvPr id="67" name="" descr=""/>
                      <p:cNvPicPr/>
                      <p:nvPr/>
                    </p:nvPicPr>
                    <p:blipFill>
                      <a:blip r:embed="rId20"/>
                      <a:stretch/>
                    </p:blipFill>
                    <p:spPr>
                      <a:xfrm>
                        <a:off x="4632120" y="5156280"/>
                        <a:ext cx="1676520" cy="1523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pic>
            <p:nvPicPr>
              <p:cNvPr id="68" name="" descr=""/>
              <p:cNvPicPr/>
              <p:nvPr/>
            </p:nvPicPr>
            <p:blipFill>
              <a:blip r:embed="rId21"/>
              <a:stretch/>
            </p:blipFill>
            <p:spPr>
              <a:xfrm>
                <a:off x="4632120" y="6745320"/>
                <a:ext cx="1676520" cy="1562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" name=""/>
              <p:cNvSpPr/>
              <p:nvPr/>
            </p:nvSpPr>
            <p:spPr>
              <a:xfrm rot="16200000">
                <a:off x="488160" y="5753160"/>
                <a:ext cx="94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onolaye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rot="16200000">
                <a:off x="216360" y="7277400"/>
                <a:ext cx="1497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ammosphe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" name=""/>
            <p:cNvSpPr/>
            <p:nvPr/>
          </p:nvSpPr>
          <p:spPr>
            <a:xfrm>
              <a:off x="746280" y="11397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40160" y="4811760"/>
              <a:ext cx="30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"/>
          <p:cNvSpPr/>
          <p:nvPr/>
        </p:nvSpPr>
        <p:spPr>
          <a:xfrm>
            <a:off x="591120" y="576360"/>
            <a:ext cx="131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1T16:20:51Z</dcterms:created>
  <dc:creator>Information Systems</dc:creator>
  <dc:description/>
  <dc:language>en-US</dc:language>
  <cp:lastModifiedBy>Information Systems</cp:lastModifiedBy>
  <dcterms:modified xsi:type="dcterms:W3CDTF">2010-05-13T22:15:29Z</dcterms:modified>
  <cp:revision>3</cp:revision>
  <dc:subject/>
  <dc:title>Slide 1</dc:title>
</cp:coreProperties>
</file>